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4/02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4/0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05264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Stephanie A. Amiel (2021) Diabetologia DOI 10.1007/s00125-020-05366-3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graphical summary of the potential consequences of hypoglycaemi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0AA9A40-8114-45E5-8435-78DDBD8BCD5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92027" y="1022841"/>
            <a:ext cx="6375969" cy="48544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</TotalTime>
  <Words>5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6</cp:revision>
  <dcterms:created xsi:type="dcterms:W3CDTF">2016-06-15T12:53:43Z</dcterms:created>
  <dcterms:modified xsi:type="dcterms:W3CDTF">2021-02-04T11:53:30Z</dcterms:modified>
</cp:coreProperties>
</file>